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4"/>
  </p:notesMasterIdLst>
  <p:sldIdLst>
    <p:sldId id="258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415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engfei Bai" initials="PB" lastIdx="1" clrIdx="0">
    <p:extLst>
      <p:ext uri="{19B8F6BF-5375-455C-9EA6-DF929625EA0E}">
        <p15:presenceInfo xmlns:p15="http://schemas.microsoft.com/office/powerpoint/2012/main" userId="f03f179874befa74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588"/>
    <p:restoredTop sz="94245"/>
  </p:normalViewPr>
  <p:slideViewPr>
    <p:cSldViewPr snapToGrid="0" showGuides="1">
      <p:cViewPr>
        <p:scale>
          <a:sx n="95" d="100"/>
          <a:sy n="95" d="100"/>
        </p:scale>
        <p:origin x="2720" y="-1040"/>
      </p:cViewPr>
      <p:guideLst>
        <p:guide orient="horz" pos="3120"/>
        <p:guide pos="415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10" Type="http://schemas.microsoft.com/office/2016/11/relationships/changesInfo" Target="changesInfos/changesInfo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ang, Guo-Liang" userId="1f9aa8c5-a4b2-412b-8732-1c1aa7e605b9" providerId="ADAL" clId="{31F380B1-40C7-0446-AD03-D6A36017D78E}"/>
    <pc:docChg chg="modSld">
      <pc:chgData name="Wang, Guo-Liang" userId="1f9aa8c5-a4b2-412b-8732-1c1aa7e605b9" providerId="ADAL" clId="{31F380B1-40C7-0446-AD03-D6A36017D78E}" dt="2024-08-07T01:29:58.177" v="16" actId="20577"/>
      <pc:docMkLst>
        <pc:docMk/>
      </pc:docMkLst>
      <pc:sldChg chg="modSp mod">
        <pc:chgData name="Wang, Guo-Liang" userId="1f9aa8c5-a4b2-412b-8732-1c1aa7e605b9" providerId="ADAL" clId="{31F380B1-40C7-0446-AD03-D6A36017D78E}" dt="2024-08-07T01:29:58.177" v="16" actId="20577"/>
        <pc:sldMkLst>
          <pc:docMk/>
          <pc:sldMk cId="1225370942" sldId="257"/>
        </pc:sldMkLst>
        <pc:spChg chg="mod">
          <ac:chgData name="Wang, Guo-Liang" userId="1f9aa8c5-a4b2-412b-8732-1c1aa7e605b9" providerId="ADAL" clId="{31F380B1-40C7-0446-AD03-D6A36017D78E}" dt="2024-08-07T01:29:58.177" v="16" actId="20577"/>
          <ac:spMkLst>
            <pc:docMk/>
            <pc:sldMk cId="1225370942" sldId="257"/>
            <ac:spMk id="6" creationId="{628D12BA-7102-C977-6BDB-206B4D90A514}"/>
          </ac:spMkLst>
        </pc:spChg>
      </pc:sldChg>
      <pc:sldChg chg="modSp mod">
        <pc:chgData name="Wang, Guo-Liang" userId="1f9aa8c5-a4b2-412b-8732-1c1aa7e605b9" providerId="ADAL" clId="{31F380B1-40C7-0446-AD03-D6A36017D78E}" dt="2024-08-07T01:29:49.619" v="14" actId="20577"/>
        <pc:sldMkLst>
          <pc:docMk/>
          <pc:sldMk cId="1189006947" sldId="258"/>
        </pc:sldMkLst>
        <pc:spChg chg="mod">
          <ac:chgData name="Wang, Guo-Liang" userId="1f9aa8c5-a4b2-412b-8732-1c1aa7e605b9" providerId="ADAL" clId="{31F380B1-40C7-0446-AD03-D6A36017D78E}" dt="2024-08-07T01:29:49.619" v="14" actId="20577"/>
          <ac:spMkLst>
            <pc:docMk/>
            <pc:sldMk cId="1189006947" sldId="258"/>
            <ac:spMk id="7" creationId="{BB97ED59-373B-8640-8413-6A834235865C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Nick\Downloads\(2)SDS2%20metabolites%20up%20and%20down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Nick\Downloads\(2)SDS2%20metabolites%20up%20and%20down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C:\Users\Nick\Downloads\(2)SDS2%20metabolites%20up%20and%20down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C:\Users\Nick\Downloads\(2)SDS2%20metabolites%20up%20and%20dow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V$68</c:f>
              <c:strCache>
                <c:ptCount val="1"/>
                <c:pt idx="0">
                  <c:v>OsKS1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W$69:$W$70</c:f>
                <c:numCache>
                  <c:formatCode>General</c:formatCode>
                  <c:ptCount val="2"/>
                  <c:pt idx="0">
                    <c:v>7.9728382728329439E-2</c:v>
                  </c:pt>
                  <c:pt idx="1">
                    <c:v>1.4846463493757585</c:v>
                  </c:pt>
                </c:numCache>
              </c:numRef>
            </c:plus>
            <c:minus>
              <c:numRef>
                <c:f>Sheet1!$W$69:$W$70</c:f>
                <c:numCache>
                  <c:formatCode>General</c:formatCode>
                  <c:ptCount val="2"/>
                  <c:pt idx="0">
                    <c:v>7.9728382728329439E-2</c:v>
                  </c:pt>
                  <c:pt idx="1">
                    <c:v>1.48464634937575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U$69:$U$70</c:f>
              <c:strCache>
                <c:ptCount val="2"/>
                <c:pt idx="0">
                  <c:v>KWT</c:v>
                </c:pt>
                <c:pt idx="1">
                  <c:v>SDS2-ACT</c:v>
                </c:pt>
              </c:strCache>
            </c:strRef>
          </c:cat>
          <c:val>
            <c:numRef>
              <c:f>Sheet1!$V$69:$V$70</c:f>
              <c:numCache>
                <c:formatCode>0.0</c:formatCode>
                <c:ptCount val="2"/>
                <c:pt idx="0">
                  <c:v>1.0015878930509481</c:v>
                </c:pt>
                <c:pt idx="1">
                  <c:v>26.7792635778717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2C4-4A42-B9DE-5176B7949B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04128112"/>
        <c:axId val="304128672"/>
      </c:barChart>
      <c:catAx>
        <c:axId val="304128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4128672"/>
        <c:crosses val="autoZero"/>
        <c:auto val="1"/>
        <c:lblAlgn val="ctr"/>
        <c:lblOffset val="100"/>
        <c:noMultiLvlLbl val="0"/>
      </c:catAx>
      <c:valAx>
        <c:axId val="304128672"/>
        <c:scaling>
          <c:orientation val="minMax"/>
        </c:scaling>
        <c:delete val="0"/>
        <c:axPos val="l"/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41281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ysClr val="windowText" lastClr="000000"/>
      </a:solidFill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V$63</c:f>
              <c:strCache>
                <c:ptCount val="1"/>
                <c:pt idx="0">
                  <c:v>OsKS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W$64:$W$65</c:f>
                <c:numCache>
                  <c:formatCode>General</c:formatCode>
                  <c:ptCount val="2"/>
                  <c:pt idx="0">
                    <c:v>6.2719837078742569E-2</c:v>
                  </c:pt>
                  <c:pt idx="1">
                    <c:v>0.89149380792581456</c:v>
                  </c:pt>
                </c:numCache>
              </c:numRef>
            </c:plus>
            <c:minus>
              <c:numRef>
                <c:f>Sheet1!$W$64:$W$65</c:f>
                <c:numCache>
                  <c:formatCode>General</c:formatCode>
                  <c:ptCount val="2"/>
                  <c:pt idx="0">
                    <c:v>6.2719837078742569E-2</c:v>
                  </c:pt>
                  <c:pt idx="1">
                    <c:v>0.891493807925814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U$64:$U$65</c:f>
              <c:strCache>
                <c:ptCount val="2"/>
                <c:pt idx="0">
                  <c:v>KWT</c:v>
                </c:pt>
                <c:pt idx="1">
                  <c:v>SDS2-ACT</c:v>
                </c:pt>
              </c:strCache>
            </c:strRef>
          </c:cat>
          <c:val>
            <c:numRef>
              <c:f>Sheet1!$V$64:$V$65</c:f>
              <c:numCache>
                <c:formatCode>0.0</c:formatCode>
                <c:ptCount val="2"/>
                <c:pt idx="0">
                  <c:v>1.0013260334884559</c:v>
                </c:pt>
                <c:pt idx="1">
                  <c:v>5.39389419841977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9D7-D24A-B43A-EFA960B718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04124752"/>
        <c:axId val="304124192"/>
      </c:barChart>
      <c:catAx>
        <c:axId val="3041247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4124192"/>
        <c:crosses val="autoZero"/>
        <c:auto val="1"/>
        <c:lblAlgn val="ctr"/>
        <c:lblOffset val="100"/>
        <c:noMultiLvlLbl val="0"/>
      </c:catAx>
      <c:valAx>
        <c:axId val="304124192"/>
        <c:scaling>
          <c:orientation val="minMax"/>
        </c:scaling>
        <c:delete val="0"/>
        <c:axPos val="l"/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41247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ysClr val="windowText" lastClr="000000"/>
      </a:solidFill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V$26</c:f>
              <c:strCache>
                <c:ptCount val="1"/>
                <c:pt idx="0">
                  <c:v>SDS2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W$27:$W$28</c:f>
                <c:numCache>
                  <c:formatCode>General</c:formatCode>
                  <c:ptCount val="2"/>
                  <c:pt idx="0">
                    <c:v>0.12502772634229012</c:v>
                  </c:pt>
                  <c:pt idx="1">
                    <c:v>0.24733047318827406</c:v>
                  </c:pt>
                </c:numCache>
              </c:numRef>
            </c:plus>
            <c:minus>
              <c:numRef>
                <c:f>Sheet1!$W$27:$W$28</c:f>
                <c:numCache>
                  <c:formatCode>General</c:formatCode>
                  <c:ptCount val="2"/>
                  <c:pt idx="0">
                    <c:v>0.12502772634229012</c:v>
                  </c:pt>
                  <c:pt idx="1">
                    <c:v>0.247330473188274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U$27:$U$28</c:f>
              <c:strCache>
                <c:ptCount val="2"/>
                <c:pt idx="0">
                  <c:v>KWT</c:v>
                </c:pt>
                <c:pt idx="1">
                  <c:v>SDS2-ACT</c:v>
                </c:pt>
              </c:strCache>
            </c:strRef>
          </c:cat>
          <c:val>
            <c:numRef>
              <c:f>Sheet1!$V$27:$V$28</c:f>
              <c:numCache>
                <c:formatCode>0.0</c:formatCode>
                <c:ptCount val="2"/>
                <c:pt idx="0">
                  <c:v>1.0052190324128132</c:v>
                </c:pt>
                <c:pt idx="1">
                  <c:v>3.59698870144361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35E-2F42-A837-6EB38E9099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2573584"/>
        <c:axId val="292569664"/>
      </c:barChart>
      <c:catAx>
        <c:axId val="2925735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2569664"/>
        <c:crosses val="autoZero"/>
        <c:auto val="1"/>
        <c:lblAlgn val="ctr"/>
        <c:lblOffset val="100"/>
        <c:noMultiLvlLbl val="0"/>
      </c:catAx>
      <c:valAx>
        <c:axId val="292569664"/>
        <c:scaling>
          <c:orientation val="minMax"/>
        </c:scaling>
        <c:delete val="0"/>
        <c:axPos val="l"/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25735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ysClr val="windowText" lastClr="000000"/>
      </a:solidFill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V$36</c:f>
              <c:strCache>
                <c:ptCount val="1"/>
                <c:pt idx="0">
                  <c:v>OsIAA9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W$37:$W$38</c:f>
                <c:numCache>
                  <c:formatCode>General</c:formatCode>
                  <c:ptCount val="2"/>
                  <c:pt idx="0">
                    <c:v>0.12574003104139533</c:v>
                  </c:pt>
                  <c:pt idx="1">
                    <c:v>0.10526907401154929</c:v>
                  </c:pt>
                </c:numCache>
              </c:numRef>
            </c:plus>
            <c:minus>
              <c:numRef>
                <c:f>Sheet1!$W$37:$W$38</c:f>
                <c:numCache>
                  <c:formatCode>General</c:formatCode>
                  <c:ptCount val="2"/>
                  <c:pt idx="0">
                    <c:v>0.12574003104139533</c:v>
                  </c:pt>
                  <c:pt idx="1">
                    <c:v>0.105269074011549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U$37:$U$38</c:f>
              <c:strCache>
                <c:ptCount val="2"/>
                <c:pt idx="0">
                  <c:v>KWT</c:v>
                </c:pt>
                <c:pt idx="1">
                  <c:v>SDS2-ACT</c:v>
                </c:pt>
              </c:strCache>
            </c:strRef>
          </c:cat>
          <c:val>
            <c:numRef>
              <c:f>Sheet1!$V$37:$V$38</c:f>
              <c:numCache>
                <c:formatCode>0.0</c:formatCode>
                <c:ptCount val="2"/>
                <c:pt idx="0">
                  <c:v>1.0054860840745288</c:v>
                </c:pt>
                <c:pt idx="1">
                  <c:v>0.536712529975390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222-5C4B-B7FF-399F94F3F6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2571344"/>
        <c:axId val="292573024"/>
      </c:barChart>
      <c:catAx>
        <c:axId val="2925713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2573024"/>
        <c:crosses val="autoZero"/>
        <c:auto val="1"/>
        <c:lblAlgn val="ctr"/>
        <c:lblOffset val="100"/>
        <c:noMultiLvlLbl val="0"/>
      </c:catAx>
      <c:valAx>
        <c:axId val="292573024"/>
        <c:scaling>
          <c:orientation val="minMax"/>
        </c:scaling>
        <c:delete val="0"/>
        <c:axPos val="l"/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25713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ysClr val="windowText" lastClr="000000"/>
      </a:solidFill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F716E2-BEAA-E943-8345-56C07569CFAF}" type="datetimeFigureOut">
              <a:rPr lang="en-US" smtClean="0"/>
              <a:t>8/6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6DD697-98B7-E44E-A1B8-81746F5542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85316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KS4 and KS10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96DD697-98B7-E44E-A1B8-81746F55426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0797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2" indent="0" algn="ctr">
              <a:buNone/>
              <a:defRPr sz="1350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199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4A413-0870-F641-BF9E-2C8DE6E8B689}" type="datetimeFigureOut">
              <a:rPr lang="en-US" smtClean="0"/>
              <a:t>8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A93C4-40D7-C241-BD8F-7EB39B6275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643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4A413-0870-F641-BF9E-2C8DE6E8B689}" type="datetimeFigureOut">
              <a:rPr lang="en-US" smtClean="0"/>
              <a:t>8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A93C4-40D7-C241-BD8F-7EB39B6275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804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4A413-0870-F641-BF9E-2C8DE6E8B689}" type="datetimeFigureOut">
              <a:rPr lang="en-US" smtClean="0"/>
              <a:t>8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A93C4-40D7-C241-BD8F-7EB39B6275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650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4A413-0870-F641-BF9E-2C8DE6E8B689}" type="datetimeFigureOut">
              <a:rPr lang="en-US" smtClean="0"/>
              <a:t>8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A93C4-40D7-C241-BD8F-7EB39B6275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310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4A413-0870-F641-BF9E-2C8DE6E8B689}" type="datetimeFigureOut">
              <a:rPr lang="en-US" smtClean="0"/>
              <a:t>8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A93C4-40D7-C241-BD8F-7EB39B6275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3734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4A413-0870-F641-BF9E-2C8DE6E8B689}" type="datetimeFigureOut">
              <a:rPr lang="en-US" smtClean="0"/>
              <a:t>8/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A93C4-40D7-C241-BD8F-7EB39B6275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5926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4A413-0870-F641-BF9E-2C8DE6E8B689}" type="datetimeFigureOut">
              <a:rPr lang="en-US" smtClean="0"/>
              <a:t>8/6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A93C4-40D7-C241-BD8F-7EB39B6275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1467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4A413-0870-F641-BF9E-2C8DE6E8B689}" type="datetimeFigureOut">
              <a:rPr lang="en-US" smtClean="0"/>
              <a:t>8/6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A93C4-40D7-C241-BD8F-7EB39B6275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5373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4A413-0870-F641-BF9E-2C8DE6E8B689}" type="datetimeFigureOut">
              <a:rPr lang="en-US" smtClean="0"/>
              <a:t>8/6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A93C4-40D7-C241-BD8F-7EB39B6275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261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4A413-0870-F641-BF9E-2C8DE6E8B689}" type="datetimeFigureOut">
              <a:rPr lang="en-US" smtClean="0"/>
              <a:t>8/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A93C4-40D7-C241-BD8F-7EB39B6275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9037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2" indent="0">
              <a:buNone/>
              <a:defRPr sz="1800"/>
            </a:lvl3pPr>
            <a:lvl4pPr marL="1028657" indent="0">
              <a:buNone/>
              <a:defRPr sz="1500"/>
            </a:lvl4pPr>
            <a:lvl5pPr marL="1371543" indent="0">
              <a:buNone/>
              <a:defRPr sz="1500"/>
            </a:lvl5pPr>
            <a:lvl6pPr marL="1714428" indent="0">
              <a:buNone/>
              <a:defRPr sz="1500"/>
            </a:lvl6pPr>
            <a:lvl7pPr marL="2057314" indent="0">
              <a:buNone/>
              <a:defRPr sz="1500"/>
            </a:lvl7pPr>
            <a:lvl8pPr marL="2400199" indent="0">
              <a:buNone/>
              <a:defRPr sz="1500"/>
            </a:lvl8pPr>
            <a:lvl9pPr marL="2743085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4A413-0870-F641-BF9E-2C8DE6E8B689}" type="datetimeFigureOut">
              <a:rPr lang="en-US" smtClean="0"/>
              <a:t>8/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A93C4-40D7-C241-BD8F-7EB39B6275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233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C4A413-0870-F641-BF9E-2C8DE6E8B689}" type="datetimeFigureOut">
              <a:rPr lang="en-US" smtClean="0"/>
              <a:t>8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6A93C4-40D7-C241-BD8F-7EB39B6275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37137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77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5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2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99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chart" Target="../charts/chart4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3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A6D4934-88DF-114F-F0B7-39401EB800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3950" y="622300"/>
            <a:ext cx="4972050" cy="415161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B97ED59-373B-8640-8413-6A834235865C}"/>
              </a:ext>
            </a:extLst>
          </p:cNvPr>
          <p:cNvSpPr txBox="1"/>
          <p:nvPr/>
        </p:nvSpPr>
        <p:spPr>
          <a:xfrm>
            <a:off x="239414" y="4956517"/>
            <a:ext cx="6302971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Several Pathogenesis related (PR) genes showed significant up-regulation in SDS2-ACT mutant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heatmap on the left panel displays the expression levels of various PR genes in SDS2-ACT compared to WT rice. The color scale represents the log2 fold change in gene expression, with red indicating up-regulation and blue indicating down-regulation. The dot plot on the right panel illustrate the log2 fold change (log2FC) and significance of these selected PR genes. The x-axis represents the log2FC, and the y-axis lists the PR genes. The size of the dots corresponds to the log2FC, and the color denotes the p-value, with red indicating higher significance. The heatmap and dot plot highlights the important roles of multiple PR genes, which may contribute to the constitutively activated immunity observed in SDS2-ACT mutant. </a:t>
            </a:r>
          </a:p>
        </p:txBody>
      </p:sp>
    </p:spTree>
    <p:extLst>
      <p:ext uri="{BB962C8B-B14F-4D97-AF65-F5344CB8AC3E}">
        <p14:creationId xmlns:p14="http://schemas.microsoft.com/office/powerpoint/2010/main" val="11890069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8FB7E37B-BD0C-4CD4-F53A-2423A83268F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9072" y="667530"/>
            <a:ext cx="2884451" cy="428547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28D12BA-7102-C977-6BDB-206B4D90A514}"/>
              </a:ext>
            </a:extLst>
          </p:cNvPr>
          <p:cNvSpPr txBox="1"/>
          <p:nvPr/>
        </p:nvSpPr>
        <p:spPr>
          <a:xfrm>
            <a:off x="410864" y="5170055"/>
            <a:ext cx="630297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. Validation of selected DEGs by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PCR. A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Heatmap showing the expression levels of 13 up-regulated and 6 down-regulated DEGs in SDS2-ACT vs. WT rice. The color scale represents the log2 fold change in gene expression, with red indicating up-regulation and blue indicating down-regulation.</a:t>
            </a:r>
          </a:p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PCR validation of selected DEGs. The bar graphs display the relative expression levels of the selected genes in SDS2-ACT compared to WT. The expression levels were normalized to the expression of the housekeeping gen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OsAct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Error bars represent the standard error of the mean (SEM) from three biological replicates.</a:t>
            </a:r>
          </a:p>
        </p:txBody>
      </p:sp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26B1AAFD-754D-F6CD-F46C-21ADFFDD196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0996118"/>
              </p:ext>
            </p:extLst>
          </p:nvPr>
        </p:nvGraphicFramePr>
        <p:xfrm>
          <a:off x="5083115" y="2662784"/>
          <a:ext cx="1111885" cy="19615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BFCF9C95-D384-CF7D-6664-E4B271FFD87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9445469"/>
              </p:ext>
            </p:extLst>
          </p:nvPr>
        </p:nvGraphicFramePr>
        <p:xfrm>
          <a:off x="3838241" y="2662783"/>
          <a:ext cx="1174115" cy="19615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3BB10AAD-0EFB-7282-98B5-101E714D782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5824120"/>
              </p:ext>
            </p:extLst>
          </p:nvPr>
        </p:nvGraphicFramePr>
        <p:xfrm>
          <a:off x="3838241" y="667530"/>
          <a:ext cx="1120140" cy="18865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147C8BCA-A6B0-371A-F650-68A86663829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6104632"/>
              </p:ext>
            </p:extLst>
          </p:nvPr>
        </p:nvGraphicFramePr>
        <p:xfrm>
          <a:off x="5105022" y="674515"/>
          <a:ext cx="1068070" cy="1879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A97F1AC7-D661-DD2F-F773-51A676A4D2A6}"/>
              </a:ext>
            </a:extLst>
          </p:cNvPr>
          <p:cNvSpPr txBox="1"/>
          <p:nvPr/>
        </p:nvSpPr>
        <p:spPr>
          <a:xfrm>
            <a:off x="305800" y="455241"/>
            <a:ext cx="2928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EBE362C-922B-748C-B614-9152DE0C8DCF}"/>
              </a:ext>
            </a:extLst>
          </p:cNvPr>
          <p:cNvSpPr txBox="1"/>
          <p:nvPr/>
        </p:nvSpPr>
        <p:spPr>
          <a:xfrm>
            <a:off x="3569952" y="455241"/>
            <a:ext cx="2928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53709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575</TotalTime>
  <Words>265</Words>
  <Application>Microsoft Macintosh PowerPoint</Application>
  <PresentationFormat>A4 Paper (210x297 mm)</PresentationFormat>
  <Paragraphs>11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ngfei Bai</dc:creator>
  <cp:lastModifiedBy>Wang, Guo-Liang</cp:lastModifiedBy>
  <cp:revision>70</cp:revision>
  <dcterms:created xsi:type="dcterms:W3CDTF">2024-01-19T23:29:41Z</dcterms:created>
  <dcterms:modified xsi:type="dcterms:W3CDTF">2024-08-07T01:30:01Z</dcterms:modified>
</cp:coreProperties>
</file>